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D2A9D-9CF7-4849-AAFF-849291FB74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D37949-6746-4456-B97C-756B1135AC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95AD1B-FF8D-4233-8EE2-8FE7A34BB3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DBEA9-9F74-45E9-B6A5-1E4345AF26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590F3-AE79-41BF-A200-293A0ECCE0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FF9D6D-6D96-4203-81EA-044C644CEB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D843C-8385-4590-972E-8992E8948E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FE3058-FB8A-4AC3-B2EF-2375CADD61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0D7EF-0295-446D-B62D-48F74A16FB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39369-79A1-471B-B8B4-DDD7DAAEA5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FABCEA-F5C9-4BA8-B196-A14F535D16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F623F3-F80D-4A9C-BEC9-07642F436F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6B7AB5-CA89-4DF6-87A2-99955288C0B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5.png"/><Relationship Id="rId8" Type="http://schemas.openxmlformats.org/officeDocument/2006/relationships/image" Target="../media/image7.png"/><Relationship Id="rId9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15560" y="34920"/>
            <a:ext cx="6697800" cy="50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1.  LD plots for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IL12B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variants in cases</a:t>
            </a:r>
            <a:r>
              <a:rPr b="0" lang="it-IT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19" descr="BISSAU_IL12BD'12710_CASES.png"/>
          <p:cNvPicPr/>
          <p:nvPr/>
        </p:nvPicPr>
        <p:blipFill>
          <a:blip r:embed="rId1"/>
          <a:stretch/>
        </p:blipFill>
        <p:spPr>
          <a:xfrm>
            <a:off x="765000" y="939960"/>
            <a:ext cx="1944720" cy="17604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0" descr="BISSAU_IL12BR212710_CASES.png"/>
          <p:cNvPicPr/>
          <p:nvPr/>
        </p:nvPicPr>
        <p:blipFill>
          <a:blip r:embed="rId2"/>
          <a:stretch/>
        </p:blipFill>
        <p:spPr>
          <a:xfrm>
            <a:off x="3860640" y="939960"/>
            <a:ext cx="1944720" cy="17589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21" descr="IL12B_Cases_Gambia_12710_d'.png"/>
          <p:cNvPicPr/>
          <p:nvPr/>
        </p:nvPicPr>
        <p:blipFill>
          <a:blip r:embed="rId3"/>
          <a:stretch/>
        </p:blipFill>
        <p:spPr>
          <a:xfrm>
            <a:off x="765000" y="2987640"/>
            <a:ext cx="1943280" cy="17766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22" descr="IL12B_Cases_Gambia_12710_r2.png"/>
          <p:cNvPicPr/>
          <p:nvPr/>
        </p:nvPicPr>
        <p:blipFill>
          <a:blip r:embed="rId4"/>
          <a:stretch/>
        </p:blipFill>
        <p:spPr>
          <a:xfrm>
            <a:off x="3860640" y="2987640"/>
            <a:ext cx="1944720" cy="17287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5" descr="Black_Cases_NoExtra121610D'.png"/>
          <p:cNvPicPr/>
          <p:nvPr/>
        </p:nvPicPr>
        <p:blipFill>
          <a:blip r:embed="rId5"/>
          <a:stretch/>
        </p:blipFill>
        <p:spPr>
          <a:xfrm>
            <a:off x="765000" y="5030640"/>
            <a:ext cx="1944720" cy="17733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3" descr="Black_Casels_NoExtra121610R2.png"/>
          <p:cNvPicPr/>
          <p:nvPr/>
        </p:nvPicPr>
        <p:blipFill>
          <a:blip r:embed="rId6"/>
          <a:stretch/>
        </p:blipFill>
        <p:spPr>
          <a:xfrm>
            <a:off x="3860640" y="5030640"/>
            <a:ext cx="1944720" cy="177336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4" descr="Black_Cases_NoExtra121610D'.png"/>
          <p:cNvPicPr/>
          <p:nvPr/>
        </p:nvPicPr>
        <p:blipFill>
          <a:blip r:embed="rId7"/>
          <a:stretch/>
        </p:blipFill>
        <p:spPr>
          <a:xfrm>
            <a:off x="765000" y="7093080"/>
            <a:ext cx="1944720" cy="17730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4" descr="White_CasesR2NoExtra121610.png"/>
          <p:cNvPicPr/>
          <p:nvPr/>
        </p:nvPicPr>
        <p:blipFill>
          <a:blip r:embed="rId8"/>
          <a:stretch/>
        </p:blipFill>
        <p:spPr>
          <a:xfrm>
            <a:off x="3860640" y="7093080"/>
            <a:ext cx="1944720" cy="177300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693000" y="2771640"/>
            <a:ext cx="1207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. The Gambia D’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794400" y="2771640"/>
            <a:ext cx="1179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. The Gambia r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93360" y="727200"/>
            <a:ext cx="136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. Guinea-Bissau D’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812040" y="727200"/>
            <a:ext cx="1340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. Guinea-Bissau r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94080" y="4832280"/>
            <a:ext cx="153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. African-American D’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795840" y="4832280"/>
            <a:ext cx="1473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. African-American r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693720" y="6877080"/>
            <a:ext cx="1122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. Caucasian D’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794760" y="6877080"/>
            <a:ext cx="108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. Caucasian r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20T14:10:03Z</dcterms:created>
  <dc:creator>fbf</dc:creator>
  <dc:description/>
  <dc:language>en-US</dc:language>
  <cp:lastModifiedBy>fbf</cp:lastModifiedBy>
  <dcterms:modified xsi:type="dcterms:W3CDTF">2010-12-22T17:35:36Z</dcterms:modified>
  <cp:revision>27</cp:revision>
  <dc:subject/>
  <dc:title>Figure  S1.  Haploview IL12B linkage disequilibrium plots for cases </dc:title>
</cp:coreProperties>
</file>